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6C8DE-5D67-4039-B8C7-74171F0381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84860-B829-4B8E-BB14-EA3E842737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AEE70-0542-461D-8A93-EB2EB0B207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E0477-4A69-4DBE-98DA-49E2D05626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CB05A-77A0-4109-AAF3-52B5FD1ECB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380FB-087F-4B78-BC25-CA4D9FC671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CD8F27-775D-468C-9749-004B0BE174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463DD-C8AC-4031-A5C1-4DB5D08218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E4D7AB-3222-4C26-91F5-CE63FEA2AC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680AA-F3AB-4C65-BE5F-5435EA0C86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8A5D5-C09A-4208-8A16-84C5925C0A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487919-B3D3-4D96-A9D0-EC419A2435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639329-CBE7-48C1-A7BB-04185A962AD9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800" spc="-1" strike="noStrike">
                <a:solidFill>
                  <a:srgbClr val="000000"/>
                </a:solidFill>
                <a:latin typeface="Calibri"/>
              </a:rPr>
              <a:t>Additional file 2_Insert sizes of representative clones from the </a:t>
            </a:r>
            <a:r>
              <a:rPr b="1" i="1" lang="zh-TW" sz="2800" spc="-1" strike="noStrike">
                <a:solidFill>
                  <a:srgbClr val="000000"/>
                </a:solidFill>
                <a:latin typeface="Calibri"/>
              </a:rPr>
              <a:t>P. monodon </a:t>
            </a:r>
            <a:r>
              <a:rPr b="1" lang="zh-TW" sz="2800" spc="-1" strike="noStrike">
                <a:solidFill>
                  <a:srgbClr val="000000"/>
                </a:solidFill>
                <a:latin typeface="Calibri"/>
              </a:rPr>
              <a:t>fosmid library</a:t>
            </a:r>
            <a:r>
              <a:rPr b="0" lang="zh-TW" sz="4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457200" y="2387520"/>
            <a:ext cx="8229600" cy="2951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29T06:12:47Z</dcterms:created>
  <dc:creator>Wei</dc:creator>
  <dc:description/>
  <dc:language>en-US</dc:language>
  <cp:lastModifiedBy>Wei</cp:lastModifiedBy>
  <dcterms:modified xsi:type="dcterms:W3CDTF">2011-03-29T06:19:07Z</dcterms:modified>
  <cp:revision>3</cp:revision>
  <dc:subject/>
  <dc:title>投影片 1</dc:title>
</cp:coreProperties>
</file>